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119813" cy="8280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713"/>
  </p:normalViewPr>
  <p:slideViewPr>
    <p:cSldViewPr snapToGrid="0" snapToObjects="1">
      <p:cViewPr varScale="1">
        <p:scale>
          <a:sx n="90" d="100"/>
          <a:sy n="90" d="100"/>
        </p:scale>
        <p:origin x="312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355149"/>
            <a:ext cx="5201841" cy="2882806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349128"/>
            <a:ext cx="4589860" cy="1999179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562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55162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40855"/>
            <a:ext cx="1319585" cy="7017256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40855"/>
            <a:ext cx="3882256" cy="7017256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1751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7645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2064352"/>
            <a:ext cx="5278339" cy="3444416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541353"/>
            <a:ext cx="5278339" cy="1811337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73094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204273"/>
            <a:ext cx="2600921" cy="52538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204273"/>
            <a:ext cx="2600921" cy="52538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9194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40856"/>
            <a:ext cx="5278339" cy="1600495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2029849"/>
            <a:ext cx="2588967" cy="994797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3024646"/>
            <a:ext cx="2588967" cy="444879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2029849"/>
            <a:ext cx="2601718" cy="994797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3024646"/>
            <a:ext cx="2601718" cy="444879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9106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49209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14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52027"/>
            <a:ext cx="1973799" cy="1932093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92226"/>
            <a:ext cx="3098155" cy="5884451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84120"/>
            <a:ext cx="1973799" cy="4602140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0123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52027"/>
            <a:ext cx="1973799" cy="1932093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92226"/>
            <a:ext cx="3098155" cy="5884451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84120"/>
            <a:ext cx="1973799" cy="4602140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9131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40856"/>
            <a:ext cx="5278339" cy="1600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204273"/>
            <a:ext cx="5278339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674706"/>
            <a:ext cx="1376958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674706"/>
            <a:ext cx="2065437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674706"/>
            <a:ext cx="1376958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06612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4FB95F57-02BF-1D44-BD0C-52292D76A3D2}"/>
              </a:ext>
            </a:extLst>
          </p:cNvPr>
          <p:cNvGrpSpPr/>
          <p:nvPr/>
        </p:nvGrpSpPr>
        <p:grpSpPr>
          <a:xfrm>
            <a:off x="0" y="1975343"/>
            <a:ext cx="6119813" cy="4329713"/>
            <a:chOff x="0" y="1975343"/>
            <a:chExt cx="6119813" cy="4329713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7F38CEE3-2860-3344-B4E1-8B7B06F9FA8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1975343"/>
              <a:ext cx="6119813" cy="4329713"/>
            </a:xfrm>
            <a:prstGeom prst="rect">
              <a:avLst/>
            </a:prstGeom>
          </p:spPr>
        </p:pic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E6FA789E-F4AF-124A-BEA0-11DC4B8054D2}"/>
                </a:ext>
              </a:extLst>
            </p:cNvPr>
            <p:cNvSpPr/>
            <p:nvPr/>
          </p:nvSpPr>
          <p:spPr>
            <a:xfrm>
              <a:off x="4371063" y="2725615"/>
              <a:ext cx="873060" cy="134572"/>
            </a:xfrm>
            <a:prstGeom prst="rect">
              <a:avLst/>
            </a:prstGeom>
            <a:solidFill>
              <a:srgbClr val="FF0000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1385AA70-EDC5-B240-BFE0-ED1A772C0FDA}"/>
                </a:ext>
              </a:extLst>
            </p:cNvPr>
            <p:cNvSpPr/>
            <p:nvPr/>
          </p:nvSpPr>
          <p:spPr>
            <a:xfrm>
              <a:off x="4371063" y="3208215"/>
              <a:ext cx="873060" cy="134572"/>
            </a:xfrm>
            <a:prstGeom prst="rect">
              <a:avLst/>
            </a:prstGeom>
            <a:solidFill>
              <a:srgbClr val="FF0000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9D139E18-1DD5-F647-A039-880B9F74448B}"/>
                </a:ext>
              </a:extLst>
            </p:cNvPr>
            <p:cNvSpPr/>
            <p:nvPr/>
          </p:nvSpPr>
          <p:spPr>
            <a:xfrm>
              <a:off x="4371063" y="2222499"/>
              <a:ext cx="873060" cy="92075"/>
            </a:xfrm>
            <a:prstGeom prst="rect">
              <a:avLst/>
            </a:prstGeom>
            <a:solidFill>
              <a:srgbClr val="FF0000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AC4C7A5E-E6B6-2F41-9D2A-FAE08E58D5B9}"/>
                </a:ext>
              </a:extLst>
            </p:cNvPr>
            <p:cNvSpPr/>
            <p:nvPr/>
          </p:nvSpPr>
          <p:spPr>
            <a:xfrm>
              <a:off x="4371063" y="2927349"/>
              <a:ext cx="873060" cy="82551"/>
            </a:xfrm>
            <a:prstGeom prst="rect">
              <a:avLst/>
            </a:prstGeom>
            <a:solidFill>
              <a:srgbClr val="FF0000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7A5ADC14-DA87-5B47-85BA-BDA39B3DB6C3}"/>
                </a:ext>
              </a:extLst>
            </p:cNvPr>
            <p:cNvSpPr/>
            <p:nvPr/>
          </p:nvSpPr>
          <p:spPr>
            <a:xfrm>
              <a:off x="4371063" y="3565525"/>
              <a:ext cx="873060" cy="75712"/>
            </a:xfrm>
            <a:prstGeom prst="rect">
              <a:avLst/>
            </a:prstGeom>
            <a:solidFill>
              <a:srgbClr val="FF0000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82FFF0EC-FA96-2645-8C2D-42414E89E327}"/>
                </a:ext>
              </a:extLst>
            </p:cNvPr>
            <p:cNvSpPr/>
            <p:nvPr/>
          </p:nvSpPr>
          <p:spPr>
            <a:xfrm>
              <a:off x="4371062" y="4177892"/>
              <a:ext cx="914245" cy="151279"/>
            </a:xfrm>
            <a:prstGeom prst="rect">
              <a:avLst/>
            </a:prstGeom>
            <a:solidFill>
              <a:srgbClr val="FF0000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0832B476-F80D-EB4A-9D6C-28DF45E5BF98}"/>
              </a:ext>
            </a:extLst>
          </p:cNvPr>
          <p:cNvSpPr txBox="1"/>
          <p:nvPr/>
        </p:nvSpPr>
        <p:spPr>
          <a:xfrm>
            <a:off x="631030" y="6443740"/>
            <a:ext cx="485775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Evolution of lemma length. Maximum likelihood tree estimated using IQTREE2 v2.1.2 inferred </a:t>
            </a:r>
            <a:r>
              <a:rPr lang="en-GB" sz="18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from 333 </a:t>
            </a:r>
            <a:r>
              <a:rPr lang="en-GB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nuclear genes. Log transformed maximum fertile lemma length (mm) in </a:t>
            </a:r>
            <a:r>
              <a:rPr lang="en-GB" sz="1800" b="0" i="1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Urochloa</a:t>
            </a:r>
            <a:r>
              <a:rPr lang="en-GB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. Ancestral trait estimation along branch lengths</a:t>
            </a:r>
            <a:endParaRPr lang="en-US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080DF78-1BAA-024F-8C13-FED81AB9001F}"/>
              </a:ext>
            </a:extLst>
          </p:cNvPr>
          <p:cNvSpPr txBox="1"/>
          <p:nvPr/>
        </p:nvSpPr>
        <p:spPr>
          <a:xfrm>
            <a:off x="67605" y="1172091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</a:t>
            </a:r>
            <a:r>
              <a:rPr lang="en-US"/>
              <a:t>Figure </a:t>
            </a:r>
            <a:r>
              <a:rPr lang="en-US" dirty="0"/>
              <a:t>5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BA406A2-597C-0E48-BC34-E11575CB0603}"/>
              </a:ext>
            </a:extLst>
          </p:cNvPr>
          <p:cNvSpPr txBox="1"/>
          <p:nvPr/>
        </p:nvSpPr>
        <p:spPr>
          <a:xfrm>
            <a:off x="67605" y="174666"/>
            <a:ext cx="19745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sters et al. </a:t>
            </a:r>
            <a:r>
              <a:rPr lang="en-US"/>
              <a:t>2024</a:t>
            </a:r>
            <a:endParaRPr lang="en-US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5C9A938-4FD0-8A41-82AB-0C5B2C9D51AB}"/>
              </a:ext>
            </a:extLst>
          </p:cNvPr>
          <p:cNvSpPr txBox="1"/>
          <p:nvPr/>
        </p:nvSpPr>
        <p:spPr>
          <a:xfrm>
            <a:off x="0" y="664075"/>
            <a:ext cx="5556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 Evolutionary origins of the African forage grass </a:t>
            </a:r>
            <a:r>
              <a:rPr lang="en-US" i="1" dirty="0"/>
              <a:t>Urochloa</a:t>
            </a:r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7507571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27</TotalTime>
  <Words>53</Words>
  <Application>Microsoft Macintosh PowerPoint</Application>
  <PresentationFormat>Custom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zo Masters</dc:creator>
  <cp:lastModifiedBy>Masters, Lizo E.</cp:lastModifiedBy>
  <cp:revision>13</cp:revision>
  <dcterms:created xsi:type="dcterms:W3CDTF">2023-06-01T15:27:18Z</dcterms:created>
  <dcterms:modified xsi:type="dcterms:W3CDTF">2024-01-25T17:28:32Z</dcterms:modified>
</cp:coreProperties>
</file>